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FADE69-ED7C-41BD-8786-EDDD7F43F4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19636-03C5-4C40-BB06-DF0B6EDDF1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A8F34-766F-4B47-9C64-27121C57437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0F58E-67B0-4E42-93D1-D1D538A7B4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6E7DE-23C1-4673-B7BE-09B1E05AEC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8B505-E6B6-4103-8819-D8DD5F1422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5F17A-988E-43E1-B78D-9EAF534B5F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F34CE-5F01-41EF-8C28-4A7BEEB9C0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9FA1C-438F-4FE4-8B36-CCE00C3FB2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287AEA-82FD-47DB-AC9E-5D650FF9E6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F267B9-F427-4FC5-A0D0-24E19C05DB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57E06-0D9F-4AEF-BF8D-43BEB0FB84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BF6492-469F-44E2-A8C2-C1ED856D3D46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s://www.ncbi.nlm.nih.gov/entrez/viewer.fcgi?db=nucleotide&amp;id=930945786" TargetMode="External"/><Relationship Id="rId2" Type="http://schemas.openxmlformats.org/officeDocument/2006/relationships/hyperlink" Target="https://www.ncbi.nlm.nih.gov/entrez/viewer.fcgi?db=nucleotide&amp;id=1907110486" TargetMode="External"/><Relationship Id="rId3" Type="http://schemas.openxmlformats.org/officeDocument/2006/relationships/hyperlink" Target="https://www.ncbi.nlm.nih.gov/entrez/viewer.fcgi?db=nucleotide&amp;id=297632386" TargetMode="External"/><Relationship Id="rId4" Type="http://schemas.openxmlformats.org/officeDocument/2006/relationships/hyperlink" Target="https://www.ncbi.nlm.nih.gov/entrez/viewer.fcgi?db=nucleotide&amp;id=323668334" TargetMode="External"/><Relationship Id="rId5" Type="http://schemas.openxmlformats.org/officeDocument/2006/relationships/hyperlink" Target="https://www.ncbi.nlm.nih.gov/entrez/viewer.fcgi?db=nucleotide&amp;id=912759070" TargetMode="External"/><Relationship Id="rId6" Type="http://schemas.openxmlformats.org/officeDocument/2006/relationships/hyperlink" Target="https://www.ncbi.nlm.nih.gov/entrez/viewer.fcgi?db=nucleotide&amp;id=165932320" TargetMode="External"/><Relationship Id="rId7" Type="http://schemas.openxmlformats.org/officeDocument/2006/relationships/hyperlink" Target="https://www.ncbi.nlm.nih.gov/entrez/viewer.fcgi?db=nucleotide&amp;id=1433354128" TargetMode="External"/><Relationship Id="rId8" Type="http://schemas.openxmlformats.org/officeDocument/2006/relationships/hyperlink" Target="https://www.ncbi.nlm.nih.gov/entrez/viewer.fcgi?db=nucleotide&amp;id=255759924" TargetMode="External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28600" y="533520"/>
          <a:ext cx="6172200" cy="5254560"/>
        </p:xfrm>
        <a:graphic>
          <a:graphicData uri="http://schemas.openxmlformats.org/drawingml/2006/table">
            <a:tbl>
              <a:tblPr/>
              <a:tblGrid>
                <a:gridCol w="838080"/>
                <a:gridCol w="990720"/>
                <a:gridCol w="2133720"/>
                <a:gridCol w="1143000"/>
                <a:gridCol w="527040"/>
                <a:gridCol w="539640"/>
              </a:tblGrid>
              <a:tr h="26028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Name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/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equences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ccession Numbe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m(℃)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bp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Itch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AATCCGTCCGGAACTATGA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宋体"/>
                        </a:rPr>
                        <a:t>NM_008395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0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09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9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CTGCCATTGCTGTCTGTT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7840"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murf1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CCTCAGACACGAACTGTC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宋体"/>
                        </a:rPr>
                        <a:t>NM_029438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0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15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TTCAGCATTTCATGGCACA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280"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murf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CTGGCAGACCTCTTAGCT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宋体"/>
                        </a:rPr>
                        <a:t>NM_025481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0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96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ATACACCTGGCCTTGTTG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280"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Wwp1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GAATGGAGACCCTGCAACAA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宋体"/>
                        </a:rPr>
                        <a:t>NM_177327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0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28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CAGGAGTTGGGAACAACAATA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7840"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beta-actin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GATGTGGATCAGCAAGCA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1"/>
                        </a:rPr>
                        <a:t>NM_007393.5 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24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9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CGCAAGTTAGGTTTTGTCA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6524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Osx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TCAAGAGTCTTAGCCAAACT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2"/>
                        </a:rPr>
                        <a:t>XM_006520519.5 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23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9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AATGATGTGAGGCCAGATG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784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unx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CTGAACTCTGCACCAAGT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宋体"/>
                        </a:rPr>
                        <a:t>NM_001145920.2 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3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233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AGGTGGCAGTGTCATCAT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28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Bsp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GGAGGAGACAACGGAGAA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3"/>
                        </a:rPr>
                        <a:t>NM_008318.3 </a:t>
                      </a:r>
                      <a:endParaRPr b="1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7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295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TAAGTGTCGCCACGAGGCT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64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Opn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CCGGTGAAAGTGACTGATT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4"/>
                        </a:rPr>
                        <a:t>NM_001204203.1 </a:t>
                      </a:r>
                      <a:endParaRPr b="1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0.5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96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TGGCTTTCATTGGAATTG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64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Ocn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CGCCTACAAACGCATCTAC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5"/>
                        </a:rPr>
                        <a:t>NM_001032298.3</a:t>
                      </a:r>
                      <a:endParaRPr b="1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6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15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AGAGAGGACAGGGAGGATCAA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8864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Sox9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GGAACAGACTCACATCTCTC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6"/>
                        </a:rPr>
                        <a:t>NM_011448.4 </a:t>
                      </a:r>
                      <a:endParaRPr b="1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3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6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CTTGCACGTCGGTTTT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64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ol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GGTCACAGAGGTTACCCA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 u="sng">
                          <a:solidFill>
                            <a:srgbClr val="000000"/>
                          </a:solidFill>
                          <a:uFillTx/>
                          <a:latin typeface="Arial"/>
                          <a:ea typeface="宋体"/>
                        </a:rPr>
                        <a:t>NM_031163</a:t>
                      </a:r>
                      <a:endParaRPr b="1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0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85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ACCAGGGGAACCACTCTCA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64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Nfkb relA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GCACAGATACCACCAAGAC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7"/>
                        </a:rPr>
                        <a:t>NM_009045.5</a:t>
                      </a:r>
                      <a:endParaRPr b="1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57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TCAGCCTCATAGAAGCCATC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79280">
                <a:tc rowSpan="2"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Nfat1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F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ACATTCTGGTCCATACGA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ea typeface="宋体"/>
                          <a:hlinkClick r:id="rId8"/>
                        </a:rPr>
                        <a:t>NM_001164112.1 </a:t>
                      </a:r>
                      <a:endParaRPr b="1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6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rowSpan="2"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132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R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宋体"/>
                        </a:rPr>
                        <a:t>CGTGTAGCTGCACAATGG</a:t>
                      </a:r>
                      <a:endParaRPr b="1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920" marR="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1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TextBox 1"/>
          <p:cNvSpPr/>
          <p:nvPr/>
        </p:nvSpPr>
        <p:spPr>
          <a:xfrm>
            <a:off x="1435680" y="271440"/>
            <a:ext cx="375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S1 Table 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	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Primer sequences and qPCR conditions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8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1T17:49:37Z</dcterms:created>
  <dc:creator>hzhang</dc:creator>
  <dc:description/>
  <dc:language>en-US</dc:language>
  <cp:lastModifiedBy>chn off28</cp:lastModifiedBy>
  <cp:lastPrinted>2021-12-14T01:35:34Z</cp:lastPrinted>
  <dcterms:modified xsi:type="dcterms:W3CDTF">2022-02-16T09:52:26Z</dcterms:modified>
  <cp:revision>31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